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5"/>
  </p:notesMasterIdLst>
  <p:sldIdLst>
    <p:sldId id="262" r:id="rId2"/>
    <p:sldId id="264" r:id="rId3"/>
    <p:sldId id="263" r:id="rId4"/>
  </p:sldIdLst>
  <p:sldSz cx="12192000" cy="6858000"/>
  <p:notesSz cx="6858000" cy="9144000"/>
  <p:custDataLst>
    <p:tags r:id="rId6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344" autoAdjust="0"/>
    <p:restoredTop sz="93206" autoAdjust="0"/>
  </p:normalViewPr>
  <p:slideViewPr>
    <p:cSldViewPr snapToGrid="0">
      <p:cViewPr varScale="1">
        <p:scale>
          <a:sx n="71" d="100"/>
          <a:sy n="71" d="100"/>
        </p:scale>
        <p:origin x="33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gs" Target="tags/tag1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7C5DFEE-1DF0-4605-B8B4-6D8350100FF9}" type="datetimeFigureOut">
              <a:rPr lang="zh-CN" altLang="en-US" smtClean="0"/>
              <a:t>2024/2/2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83E1F76-76C5-4150-9DA4-A99E44835E7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83E1F76-76C5-4150-9DA4-A99E44835E74}" type="slidenum">
              <a:rPr lang="zh-CN" altLang="en-US" smtClean="0"/>
              <a:t>1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911D5-C284-4292-88C9-4FD4042664B4}" type="datetimeFigureOut">
              <a:rPr lang="zh-CN" altLang="en-US" smtClean="0"/>
              <a:t>2024/2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A4698-7A70-4079-B5AF-9842438B439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911D5-C284-4292-88C9-4FD4042664B4}" type="datetimeFigureOut">
              <a:rPr lang="zh-CN" altLang="en-US" smtClean="0"/>
              <a:t>2024/2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A4698-7A70-4079-B5AF-9842438B439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911D5-C284-4292-88C9-4FD4042664B4}" type="datetimeFigureOut">
              <a:rPr lang="zh-CN" altLang="en-US" smtClean="0"/>
              <a:t>2024/2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A4698-7A70-4079-B5AF-9842438B439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911D5-C284-4292-88C9-4FD4042664B4}" type="datetimeFigureOut">
              <a:rPr lang="zh-CN" altLang="en-US" smtClean="0"/>
              <a:t>2024/2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A4698-7A70-4079-B5AF-9842438B439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911D5-C284-4292-88C9-4FD4042664B4}" type="datetimeFigureOut">
              <a:rPr lang="zh-CN" altLang="en-US" smtClean="0"/>
              <a:t>2024/2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A4698-7A70-4079-B5AF-9842438B439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911D5-C284-4292-88C9-4FD4042664B4}" type="datetimeFigureOut">
              <a:rPr lang="zh-CN" altLang="en-US" smtClean="0"/>
              <a:t>2024/2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A4698-7A70-4079-B5AF-9842438B439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911D5-C284-4292-88C9-4FD4042664B4}" type="datetimeFigureOut">
              <a:rPr lang="zh-CN" altLang="en-US" smtClean="0"/>
              <a:t>2024/2/2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A4698-7A70-4079-B5AF-9842438B439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911D5-C284-4292-88C9-4FD4042664B4}" type="datetimeFigureOut">
              <a:rPr lang="zh-CN" altLang="en-US" smtClean="0"/>
              <a:t>2024/2/2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A4698-7A70-4079-B5AF-9842438B439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911D5-C284-4292-88C9-4FD4042664B4}" type="datetimeFigureOut">
              <a:rPr lang="zh-CN" altLang="en-US" smtClean="0"/>
              <a:t>2024/2/2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A4698-7A70-4079-B5AF-9842438B439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911D5-C284-4292-88C9-4FD4042664B4}" type="datetimeFigureOut">
              <a:rPr lang="zh-CN" altLang="en-US" smtClean="0"/>
              <a:t>2024/2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A4698-7A70-4079-B5AF-9842438B439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911D5-C284-4292-88C9-4FD4042664B4}" type="datetimeFigureOut">
              <a:rPr lang="zh-CN" altLang="en-US" smtClean="0"/>
              <a:t>2024/2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A4698-7A70-4079-B5AF-9842438B439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7911D5-C284-4292-88C9-4FD4042664B4}" type="datetimeFigureOut">
              <a:rPr lang="zh-CN" altLang="en-US" smtClean="0"/>
              <a:t>2024/2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0A4698-7A70-4079-B5AF-9842438B439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7"/>
          <p:cNvSpPr>
            <a:spLocks noChangeArrowheads="1"/>
          </p:cNvSpPr>
          <p:nvPr/>
        </p:nvSpPr>
        <p:spPr bwMode="auto">
          <a:xfrm>
            <a:off x="1340485" y="234950"/>
            <a:ext cx="9604375" cy="3067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9pPr>
          </a:lstStyle>
          <a:p>
            <a:pPr algn="l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1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s used in this study</a:t>
            </a:r>
          </a:p>
        </p:txBody>
      </p:sp>
      <p:graphicFrame>
        <p:nvGraphicFramePr>
          <p:cNvPr id="5" name="表格 4"/>
          <p:cNvGraphicFramePr>
            <a:graphicFrameLocks noGrp="1"/>
          </p:cNvGraphicFramePr>
          <p:nvPr/>
        </p:nvGraphicFramePr>
        <p:xfrm>
          <a:off x="1341157" y="705132"/>
          <a:ext cx="9268572" cy="53644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60094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69713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22237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74811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227611">
                <a:tc>
                  <a:txBody>
                    <a:bodyPr/>
                    <a:lstStyle/>
                    <a:p>
                      <a:pPr algn="l"/>
                      <a:endParaRPr lang="zh-CN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er name</a:t>
                      </a:r>
                      <a:endParaRPr lang="zh-CN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quence</a:t>
                      </a:r>
                      <a:endParaRPr lang="zh-CN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XB2 location</a:t>
                      </a:r>
                      <a:endParaRPr lang="zh-CN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27611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T primer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5073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fr-FR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′-CCACACAATCATCACCTGCC-3′ 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73-5092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27611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plification primer sets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-F1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′-TTGGAAATGTGGAAAGGAAGGAC-3′ 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8-2050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27611">
                <a:tc>
                  <a:txBody>
                    <a:bodyPr/>
                    <a:lstStyle/>
                    <a:p>
                      <a:pPr algn="l"/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T-R1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′-CTGTATTTCTGCTATTAAGTCTTTTGATGGG-3′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09-3539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27611">
                <a:tc>
                  <a:txBody>
                    <a:bodyPr/>
                    <a:lstStyle/>
                    <a:p>
                      <a:pPr algn="l"/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-F2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′-CAGAGCCAACAGCCCCACCA-3’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47-2166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27611">
                <a:tc>
                  <a:txBody>
                    <a:bodyPr/>
                    <a:lstStyle/>
                    <a:p>
                      <a:pPr algn="l"/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T-R2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′-CTGCCAGTTCTAGCTCTGCTTC-3′ 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41-3462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27611">
                <a:tc>
                  <a:txBody>
                    <a:bodyPr/>
                    <a:lstStyle/>
                    <a:p>
                      <a:pPr algn="l"/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4181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sv-SE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′-AATGAACAAGTAGATAAATTAGT-3′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81–4203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27611">
                <a:tc>
                  <a:txBody>
                    <a:bodyPr/>
                    <a:lstStyle/>
                    <a:p>
                      <a:pPr algn="l"/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5073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fr-FR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′-CCACACAATCATCACCTGCC-3′ 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73-5092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27611">
                <a:tc>
                  <a:txBody>
                    <a:bodyPr/>
                    <a:lstStyle/>
                    <a:p>
                      <a:pPr algn="l"/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4379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′-CATGGACAAGTAGACTGTAGTCC-3′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79–4401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27611">
                <a:tc>
                  <a:txBody>
                    <a:bodyPr/>
                    <a:lstStyle/>
                    <a:p>
                      <a:pPr algn="l"/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5057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′- GCCATCTGTTTTCCATA-3′ 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57-5073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27611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quencing primer sets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F1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′-CACTCTTTGGCAACGACCC-3′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60-2278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27611">
                <a:tc>
                  <a:txBody>
                    <a:bodyPr/>
                    <a:lstStyle/>
                    <a:p>
                      <a:pPr algn="l"/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F3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nl-NL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′-AATTGGGCCTGAAAATCC -3′ 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94-2711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27611">
                <a:tc>
                  <a:txBody>
                    <a:bodyPr/>
                    <a:lstStyle/>
                    <a:p>
                      <a:pPr algn="l"/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2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sv-SE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′-GGATTTTCAGGCCCAATT -3′ 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00-2618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27611">
                <a:tc>
                  <a:txBody>
                    <a:bodyPr/>
                    <a:lstStyle/>
                    <a:p>
                      <a:pPr algn="l"/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4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′-GGAATATTGCTGGTGATCC-3′ 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14-3033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27611">
                <a:tc>
                  <a:txBody>
                    <a:bodyPr/>
                    <a:lstStyle/>
                    <a:p>
                      <a:pPr algn="l"/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F2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′-GTTGACTCAGATTGGTTG -3’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19-2537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27611">
                <a:tc>
                  <a:txBody>
                    <a:bodyPr/>
                    <a:lstStyle/>
                    <a:p>
                      <a:pPr algn="r"/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F4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sv-SE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′-TGGAGAAAATTAGTAGATTT-3’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60-2780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27611">
                <a:tc>
                  <a:txBody>
                    <a:bodyPr/>
                    <a:lstStyle/>
                    <a:p>
                      <a:pPr algn="r"/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1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′-ATAAAACCTCCAATTCC-3′ 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96-2413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27611">
                <a:tc>
                  <a:txBody>
                    <a:bodyPr/>
                    <a:lstStyle/>
                    <a:p>
                      <a:pPr algn="r"/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3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′-CTGTCCTTTTTCTTTAT-3′ 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36-2753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27611">
                <a:tc>
                  <a:txBody>
                    <a:bodyPr/>
                    <a:lstStyle/>
                    <a:p>
                      <a:pPr algn="r"/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F5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sv-SE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′-TAGCAGGAAGATGGCCAGT-3′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40–4559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27611">
                <a:tc>
                  <a:txBody>
                    <a:bodyPr/>
                    <a:lstStyle/>
                    <a:p>
                      <a:pPr algn="r"/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5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′-GCTGGTCCTTTCCAAA-3′ 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931–4944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27611">
                <a:tc>
                  <a:txBody>
                    <a:bodyPr/>
                    <a:lstStyle/>
                    <a:p>
                      <a:pPr algn="r"/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F6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zh-CN" sz="1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′-AGAAAAGGGGGGATTGG-3</a:t>
                      </a: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′ 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88–4804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227611">
                <a:tc>
                  <a:txBody>
                    <a:bodyPr/>
                    <a:lstStyle/>
                    <a:p>
                      <a:pPr algn="r"/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5057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′- GCCATCTGTTTTCCATA-3′ 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57-5073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</a:tbl>
          </a:graphicData>
        </a:graphic>
      </p:graphicFrame>
      <p:sp>
        <p:nvSpPr>
          <p:cNvPr id="8" name="文本框 7"/>
          <p:cNvSpPr txBox="1"/>
          <p:nvPr/>
        </p:nvSpPr>
        <p:spPr>
          <a:xfrm>
            <a:off x="1168120" y="6232790"/>
            <a:ext cx="609824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T, Reverse transcription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表格 7"/>
          <p:cNvGraphicFramePr>
            <a:graphicFrameLocks noGrp="1"/>
          </p:cNvGraphicFramePr>
          <p:nvPr/>
        </p:nvGraphicFramePr>
        <p:xfrm>
          <a:off x="1854201" y="762000"/>
          <a:ext cx="9182099" cy="4757810"/>
        </p:xfrm>
        <a:graphic>
          <a:graphicData uri="http://schemas.openxmlformats.org/drawingml/2006/table">
            <a:tbl>
              <a:tblPr/>
              <a:tblGrid>
                <a:gridCol w="279399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176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715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2070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1590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86360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85090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520700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584200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</a:tblGrid>
              <a:tr h="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haracteristic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LLV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iLLV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otal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DRM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10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χ</a:t>
                      </a:r>
                      <a:r>
                        <a:rPr lang="el-GR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</a:t>
                      </a:r>
                      <a:endParaRPr lang="el-GR" sz="10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otal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DRM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10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χ</a:t>
                      </a:r>
                      <a:r>
                        <a:rPr lang="el-GR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</a:t>
                      </a:r>
                      <a:endParaRPr lang="el-GR" sz="10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Sex, n (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47 (100.0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2 (46.81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57 (100.0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2 (38.6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Mal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40 (85.11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9 (47.5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05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57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42 (73.68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4 (33.33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.86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14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emal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7 (14.89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 (42.86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5 (26.32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8 (53.33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ge at diagnosis,</a:t>
                      </a:r>
                      <a:b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</a:b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Years, Median, (IQR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&lt; 30 years, n (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8 (17.02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7 (87.5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8.76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06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5 (8.77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5 (100.0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0.99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02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0-39 years, n (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3 (27.66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 (23.08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4 (24.56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5 (35.71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40-49 years, n (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0 (21.28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4 (40.0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8 (14.04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 (12.5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50-59 years, n (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7 (14.89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4 (57.14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9 (33.33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8 (42.11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38210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mbria Math" panose="02040503050406030204" pitchFamily="18" charset="0"/>
                          <a:ea typeface="等线" panose="02010600030101010101" pitchFamily="2" charset="-122"/>
                        </a:rPr>
                        <a:t>≥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60 years,n (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9 (19.15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4 (44.44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1 (19.3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 (27.27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Marriage, n (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Marrie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7 (57.45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0 (37.04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.97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1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4 (59.65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2 (35.29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.86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41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Singl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0 (42.55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2 (60.0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3 (40.35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0 (43.48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ransmission category, n (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HSX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3 (48.94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1 (47.83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.19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9 (33.33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4 (21.05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7.66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10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MSM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6 (34.04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6 (37.5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0 (35.09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8 (40.0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L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 (6.38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 (66.67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5 (26.32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8 (53.33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MTCT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 (2.13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 (100.0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 (3.51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 (100.0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Other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4 (8.51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 (50.0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 (1.75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 (0.0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Occupation, n  (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armer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 (6.38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 (100.0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.93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1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2 (21.05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9 (75.0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8.48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03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Worker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2 (46.81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9 (40.91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2 (38.6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7 (31.82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Non-worker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 (6.38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 (33.33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7 (12.28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 (14.29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Other/Unknown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9 (40.43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9 (47.37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5 (26.32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5 (33.33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Education, n (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ollege below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5 (31.91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6 (40.0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53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36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8 (49.12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0 (35.71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.24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21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ollege or abov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3 (27.66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7 (53.85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5 (26.32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8 (53.33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Unknown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9 (40.43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9 (47.37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4 (24.56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4 (28.57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</a:tbl>
          </a:graphicData>
        </a:graphic>
      </p:graphicFrame>
      <p:sp>
        <p:nvSpPr>
          <p:cNvPr id="2" name="矩形 7"/>
          <p:cNvSpPr>
            <a:spLocks noChangeArrowheads="1"/>
          </p:cNvSpPr>
          <p:nvPr/>
        </p:nvSpPr>
        <p:spPr bwMode="auto">
          <a:xfrm>
            <a:off x="1196789" y="264175"/>
            <a:ext cx="1078155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</a:t>
            </a:r>
            <a:r>
              <a: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haracteristics of 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ople living with HIV (PLWH) who presented with low-level viremia in Zhengzhou City, 2023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表格 7"/>
          <p:cNvGraphicFramePr>
            <a:graphicFrameLocks noGrp="1"/>
          </p:cNvGraphicFramePr>
          <p:nvPr/>
        </p:nvGraphicFramePr>
        <p:xfrm>
          <a:off x="1752601" y="534101"/>
          <a:ext cx="9182099" cy="6139007"/>
        </p:xfrm>
        <a:graphic>
          <a:graphicData uri="http://schemas.openxmlformats.org/drawingml/2006/table">
            <a:tbl>
              <a:tblPr/>
              <a:tblGrid>
                <a:gridCol w="279399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176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715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2070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1590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86360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85090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520700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584200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</a:tblGrid>
              <a:tr h="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haracteristic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LLV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iLLV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65801"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otal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DRM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10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χ</a:t>
                      </a:r>
                      <a:r>
                        <a:rPr lang="el-GR" sz="1000" b="0" i="1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</a:t>
                      </a:r>
                      <a:endParaRPr lang="el-GR" sz="1000" b="1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otal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DRM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10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χ</a:t>
                      </a:r>
                      <a:r>
                        <a:rPr lang="el-GR" sz="10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</a:t>
                      </a:r>
                      <a:endParaRPr lang="el-GR" sz="10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5801">
                <a:tc>
                  <a:txBody>
                    <a:bodyPr/>
                    <a:lstStyle/>
                    <a:p>
                      <a:pPr algn="l" fontAlgn="ctr"/>
                      <a:r>
                        <a:rPr lang="da-DK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VL at LLV (copies/m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65801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50-20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4 (72.34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2 (35.29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9.7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00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40 (70.18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2 (30.0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4.35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11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65801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01-40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6 (12.77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 (50.0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3 (22.81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8 (61.54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65801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401-100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7 (14.89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7 (100.0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4 (7.02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 (50.0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792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D4 + T cell count at LLV, median (IQR), cells/µL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65801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&lt;10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 (4.26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 (50.0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5.2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07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 (1.75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 (100.0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.5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4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65801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00-25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0 (21.28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 (30.0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5 (26.32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7 (46.67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65801">
                <a:tc>
                  <a:txBody>
                    <a:bodyPr/>
                    <a:lstStyle/>
                    <a:p>
                      <a:pPr algn="r" fontAlgn="ctr"/>
                      <a:r>
                        <a:rPr lang="zh-CN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≥</a:t>
                      </a:r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5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2 (46.81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6 (72.73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0 (52.63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2 (40.0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658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Log (Baseline VL)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65801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&lt;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 (6.38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 (0.0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.12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20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 (5.26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 (33.33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37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82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65801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-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5 (31.91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8 (53.33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2 (21.05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5 (41.67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31431">
                <a:tc>
                  <a:txBody>
                    <a:bodyPr/>
                    <a:lstStyle/>
                    <a:p>
                      <a:pPr algn="r" fontAlgn="ctr"/>
                      <a:r>
                        <a:rPr lang="zh-CN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mbria Math" panose="02040503050406030204" pitchFamily="18" charset="0"/>
                          <a:ea typeface="等线" panose="02010600030101010101" pitchFamily="2" charset="-122"/>
                        </a:rPr>
                        <a:t>≥</a:t>
                      </a:r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1 (23.4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6 (54.55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4 (7.02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 (25.0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792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Baseline CD4+ T cell count  median (IQR), cells/µL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65801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&lt;10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0 (21.28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 (30.0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.72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25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4 (24.56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 (21.43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4.31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11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65801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00-25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2 (25.53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5 (41.67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1 (19.3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 (18.18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65801">
                <a:tc>
                  <a:txBody>
                    <a:bodyPr/>
                    <a:lstStyle/>
                    <a:p>
                      <a:pPr algn="r" fontAlgn="ctr"/>
                      <a:r>
                        <a:rPr lang="zh-CN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≥</a:t>
                      </a:r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5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8 (38.3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1 (61.11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8 (21.58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9 (50.0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658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Delay of ART initiation (IQR), month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65801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2 (46.81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0 (45.45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5.09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27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2 (56.14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1 (34.38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6.60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15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65801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1-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9 (19.15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 (22.22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2 (21.05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6 (50.0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65801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.1-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6 (12.77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4 (66.67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6 (10.53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4 (66.67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65801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6.1-1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 (6.38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 (100.0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4 (7.02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 (25.0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65801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&gt;1</a:t>
                      </a:r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7 (14.89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 (42.86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 (5.26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 (0.0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792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ime since ART initiation, median (IQR), year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232077">
                <a:tc>
                  <a:txBody>
                    <a:bodyPr/>
                    <a:lstStyle/>
                    <a:p>
                      <a:pPr algn="r" fontAlgn="ctr"/>
                      <a:r>
                        <a:rPr lang="zh-CN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mbria Math" panose="02040503050406030204" pitchFamily="18" charset="0"/>
                          <a:ea typeface="等线" panose="02010600030101010101" pitchFamily="2" charset="-122"/>
                        </a:rPr>
                        <a:t>≤</a:t>
                      </a:r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6 (12.77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 (50.0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86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64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7 (12.28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 (42.86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87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64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-5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4 (29.79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8 (57.14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8 (31.58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5 (27.78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65100">
                <a:tc>
                  <a:txBody>
                    <a:bodyPr/>
                    <a:lstStyle/>
                    <a:p>
                      <a:pPr algn="r" fontAlgn="ctr"/>
                      <a:r>
                        <a:rPr lang="zh-CN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≥</a:t>
                      </a:r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5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4 (51.06%)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0 (41.67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0 (52.63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2 (40.0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658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Initial ART regimen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165801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NRTI+NNRTI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1 (65.96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8 (58.06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.99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08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45 (78.95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5 (33.33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.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49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65801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NRTI+PI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 (4.26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 (0.0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 (5.26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 (66.67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65801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NRTI+INSTI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1 (23.4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 (27.27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5 (8.78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 (40.0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1658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RT regimen when LLV was detecte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165801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NRTI+NNRTI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0 (42.55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3 (65.0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9.16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7 (47.37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8 (29.63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1.78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0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165801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NRTI+PI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5 (10.64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4 (80.0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9 (15.79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8 (88.89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165801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NRTI+INSTI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8 (38.3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4 (22.22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6 (28.07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4 (25.0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N2Y5OWYwMTI0NGQxYzExZjYwZjQ4ODc2MDRiOWQyNDcifQ==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29</Words>
  <Application>Microsoft Office PowerPoint</Application>
  <PresentationFormat>宽屏</PresentationFormat>
  <Paragraphs>409</Paragraphs>
  <Slides>3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0" baseType="lpstr">
      <vt:lpstr>等线</vt:lpstr>
      <vt:lpstr>等线 Light</vt:lpstr>
      <vt:lpstr>宋体</vt:lpstr>
      <vt:lpstr>Arial</vt:lpstr>
      <vt:lpstr>Cambria Math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7210</dc:creator>
  <cp:lastModifiedBy>a7210</cp:lastModifiedBy>
  <cp:revision>156</cp:revision>
  <dcterms:created xsi:type="dcterms:W3CDTF">2023-09-28T01:05:00Z</dcterms:created>
  <dcterms:modified xsi:type="dcterms:W3CDTF">2024-02-28T02:08:3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66195FF7BF584F0BAACADD74E7D81E8B_12</vt:lpwstr>
  </property>
  <property fmtid="{D5CDD505-2E9C-101B-9397-08002B2CF9AE}" pid="3" name="KSOProductBuildVer">
    <vt:lpwstr>2052-12.1.0.16388</vt:lpwstr>
  </property>
</Properties>
</file>